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2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2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95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56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248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463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266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905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7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59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13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96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59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9FAAEE6F-ADF0-42E0-B9DF-C384293344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401" y="142469"/>
            <a:ext cx="2819175" cy="2048447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6AD2C1DD-2E77-4AE1-8D34-26B71D278C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43326" y="142469"/>
            <a:ext cx="2819175" cy="2048447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2B40C5A2-8926-49CA-9840-94CB0190E31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7550" y="4531384"/>
            <a:ext cx="2858944" cy="2077343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CBC04684-5CA6-41F2-B012-EEC444EB578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47000" y="4531384"/>
            <a:ext cx="2858944" cy="2077343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26842B7-73C8-45B3-AAA2-BB30680ACA4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7076" y="2285494"/>
            <a:ext cx="2805975" cy="2038856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EDE01306-F446-4698-BE14-5F5A7843FCF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56526" y="2285494"/>
            <a:ext cx="2805975" cy="2038856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7B50B142-B4F3-46A3-A88B-D9096DEF28A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7540" y="6635526"/>
            <a:ext cx="2872142" cy="2086933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303669F6-C835-460C-A76C-B11F8D45184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27465" y="6635526"/>
            <a:ext cx="2872142" cy="2086933"/>
          </a:xfrm>
          <a:prstGeom prst="rect">
            <a:avLst/>
          </a:prstGeom>
        </p:spPr>
      </p:pic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099204FA-D4DD-4B4D-998C-8D757B622AE0}"/>
              </a:ext>
            </a:extLst>
          </p:cNvPr>
          <p:cNvSpPr txBox="1"/>
          <p:nvPr/>
        </p:nvSpPr>
        <p:spPr>
          <a:xfrm rot="16200000">
            <a:off x="2876215" y="752627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7805189A-2850-4E33-9F8F-F052AC433E02}"/>
              </a:ext>
            </a:extLst>
          </p:cNvPr>
          <p:cNvSpPr txBox="1"/>
          <p:nvPr/>
        </p:nvSpPr>
        <p:spPr>
          <a:xfrm>
            <a:off x="5211586" y="85971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083E3D16-5D92-481F-BFDE-DA271EBE170A}"/>
              </a:ext>
            </a:extLst>
          </p:cNvPr>
          <p:cNvSpPr txBox="1"/>
          <p:nvPr/>
        </p:nvSpPr>
        <p:spPr>
          <a:xfrm>
            <a:off x="1534173" y="6819079"/>
            <a:ext cx="20476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5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24 (2.78: 1.19-6.48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.92 (0.29: 0.10-0.8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0.96 (1.06: 1.01-1.1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44: 0.22-0.87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671573F8-D9D3-421B-9A06-108A56A079D6}"/>
              </a:ext>
            </a:extLst>
          </p:cNvPr>
          <p:cNvSpPr txBox="1"/>
          <p:nvPr/>
        </p:nvSpPr>
        <p:spPr>
          <a:xfrm rot="16200000">
            <a:off x="-333005" y="752627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CA50E9CC-DE7F-44B4-BA1A-96F701CD1E6F}"/>
              </a:ext>
            </a:extLst>
          </p:cNvPr>
          <p:cNvSpPr txBox="1"/>
          <p:nvPr/>
        </p:nvSpPr>
        <p:spPr>
          <a:xfrm>
            <a:off x="2002366" y="85971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10B42CAE-1044-4125-B927-F9735DC1DEBE}"/>
              </a:ext>
            </a:extLst>
          </p:cNvPr>
          <p:cNvSpPr txBox="1"/>
          <p:nvPr/>
        </p:nvSpPr>
        <p:spPr>
          <a:xfrm>
            <a:off x="4801761" y="6826016"/>
            <a:ext cx="20562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53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24 (2.81: 1.18-6.72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.92 (0.29: 0.10-0.82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0.96 (1.06: 1.01-1.1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44: 0.22-0.88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880E8DE3-5FB3-4B07-A88E-DCC0FB81FEE2}"/>
              </a:ext>
            </a:extLst>
          </p:cNvPr>
          <p:cNvSpPr txBox="1"/>
          <p:nvPr/>
        </p:nvSpPr>
        <p:spPr>
          <a:xfrm rot="16200000">
            <a:off x="2876215" y="542315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BCC3CBC6-3269-4239-8072-8A141DCD8F32}"/>
              </a:ext>
            </a:extLst>
          </p:cNvPr>
          <p:cNvSpPr txBox="1"/>
          <p:nvPr/>
        </p:nvSpPr>
        <p:spPr>
          <a:xfrm>
            <a:off x="5211586" y="649403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DC8AFD4A-587C-478F-A2E2-4BF2B799DA62}"/>
              </a:ext>
            </a:extLst>
          </p:cNvPr>
          <p:cNvSpPr txBox="1"/>
          <p:nvPr/>
        </p:nvSpPr>
        <p:spPr>
          <a:xfrm>
            <a:off x="1344512" y="4746032"/>
            <a:ext cx="20476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21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51 (3.70: 2.25-6.09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.92 (0.09: 0.03-0.22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 (1.00: 1.00-1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20: 0.11-0.3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0AFE0A91-BFF3-40CA-97DC-3A8F102BD01A}"/>
              </a:ext>
            </a:extLst>
          </p:cNvPr>
          <p:cNvSpPr txBox="1"/>
          <p:nvPr/>
        </p:nvSpPr>
        <p:spPr>
          <a:xfrm rot="16200000">
            <a:off x="-333005" y="542315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014E5B54-BD2E-40DA-AAEB-FEFC1E38D1DC}"/>
              </a:ext>
            </a:extLst>
          </p:cNvPr>
          <p:cNvSpPr txBox="1"/>
          <p:nvPr/>
        </p:nvSpPr>
        <p:spPr>
          <a:xfrm>
            <a:off x="2002366" y="649403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E3B0169D-7862-464C-9B31-90567C7121E3}"/>
              </a:ext>
            </a:extLst>
          </p:cNvPr>
          <p:cNvSpPr txBox="1"/>
          <p:nvPr/>
        </p:nvSpPr>
        <p:spPr>
          <a:xfrm>
            <a:off x="4747473" y="4746364"/>
            <a:ext cx="211052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24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51 (3.57: 2.22-5.74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.92 (0.09: 0.04-0.22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 (1.00: 1.00-1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21: 0.11-0.37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68E6F726-B0FA-4642-AB31-C80F0E51EB18}"/>
              </a:ext>
            </a:extLst>
          </p:cNvPr>
          <p:cNvSpPr txBox="1"/>
          <p:nvPr/>
        </p:nvSpPr>
        <p:spPr>
          <a:xfrm rot="16200000">
            <a:off x="2876215" y="316001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BB96BB28-EEAB-40B0-A69B-C5DCDB88190A}"/>
              </a:ext>
            </a:extLst>
          </p:cNvPr>
          <p:cNvSpPr txBox="1"/>
          <p:nvPr/>
        </p:nvSpPr>
        <p:spPr>
          <a:xfrm>
            <a:off x="5211586" y="423089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E5D3EA54-2195-42F8-A0C4-C6CEFF6DAE53}"/>
              </a:ext>
            </a:extLst>
          </p:cNvPr>
          <p:cNvSpPr txBox="1"/>
          <p:nvPr/>
        </p:nvSpPr>
        <p:spPr>
          <a:xfrm>
            <a:off x="1334987" y="2482892"/>
            <a:ext cx="20476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6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44 (1.76: 1.01-3.07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2.08 (0.33: 0.12-0.97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2 (0.98: 0.96-1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54: 0.29-0.98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AD4A6A26-1ED8-40CB-98D5-C85D2A91F620}"/>
              </a:ext>
            </a:extLst>
          </p:cNvPr>
          <p:cNvSpPr txBox="1"/>
          <p:nvPr/>
        </p:nvSpPr>
        <p:spPr>
          <a:xfrm rot="16200000">
            <a:off x="-333005" y="316001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DACDD084-773C-4002-8757-CAD420E6F51F}"/>
              </a:ext>
            </a:extLst>
          </p:cNvPr>
          <p:cNvSpPr txBox="1"/>
          <p:nvPr/>
        </p:nvSpPr>
        <p:spPr>
          <a:xfrm>
            <a:off x="2002366" y="423089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2BFC9AAD-E7EE-401A-931E-3DA4CAD67856}"/>
              </a:ext>
            </a:extLst>
          </p:cNvPr>
          <p:cNvSpPr txBox="1"/>
          <p:nvPr/>
        </p:nvSpPr>
        <p:spPr>
          <a:xfrm>
            <a:off x="4752731" y="2475050"/>
            <a:ext cx="211052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4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2 (0.98: 0.96-1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58: 0.31-1.0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A5450BB9-9F94-4220-A3B9-9020B8155C0E}"/>
              </a:ext>
            </a:extLst>
          </p:cNvPr>
          <p:cNvSpPr txBox="1"/>
          <p:nvPr/>
        </p:nvSpPr>
        <p:spPr>
          <a:xfrm rot="16200000">
            <a:off x="2876215" y="101117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FA58BD16-A775-4C4B-8423-2B29804F03DA}"/>
              </a:ext>
            </a:extLst>
          </p:cNvPr>
          <p:cNvSpPr txBox="1"/>
          <p:nvPr/>
        </p:nvSpPr>
        <p:spPr>
          <a:xfrm>
            <a:off x="5211586" y="20820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70028647-2079-4187-8C60-E10E565AA4F4}"/>
              </a:ext>
            </a:extLst>
          </p:cNvPr>
          <p:cNvSpPr txBox="1"/>
          <p:nvPr/>
        </p:nvSpPr>
        <p:spPr>
          <a:xfrm>
            <a:off x="1344512" y="334052"/>
            <a:ext cx="20476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49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44 (1.92: 1.07-3.44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2.08 (0.28: 0.09-0.88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4 (0.95: 0.92-1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49: 0.26-0.93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5EF2889C-9BE4-49C6-A76E-4C446708245B}"/>
              </a:ext>
            </a:extLst>
          </p:cNvPr>
          <p:cNvSpPr txBox="1"/>
          <p:nvPr/>
        </p:nvSpPr>
        <p:spPr>
          <a:xfrm rot="16200000">
            <a:off x="-333005" y="101117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23505FE4-19CA-4787-80BB-3CE64DBCEC1B}"/>
              </a:ext>
            </a:extLst>
          </p:cNvPr>
          <p:cNvSpPr txBox="1"/>
          <p:nvPr/>
        </p:nvSpPr>
        <p:spPr>
          <a:xfrm>
            <a:off x="2002366" y="20820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6A591DE7-53D5-4D71-AF35-B4A37724EFF4}"/>
              </a:ext>
            </a:extLst>
          </p:cNvPr>
          <p:cNvSpPr txBox="1"/>
          <p:nvPr/>
        </p:nvSpPr>
        <p:spPr>
          <a:xfrm>
            <a:off x="4755527" y="332815"/>
            <a:ext cx="211052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5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44 (1.87: 1.04-3.36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2.08 (0.30: 0.10-0.93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4 (0.96: 0.92-1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51: 0.27-0.9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704850" y="10829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993868" y="11393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0" y="8746824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4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ose-response relationships of UGS with incident disability and mortality risks, excluding disabilities or deaths that occurred during the first year of follow-up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F66FDD1-38C4-4C41-8CDD-B1C9287E5928}"/>
              </a:ext>
            </a:extLst>
          </p:cNvPr>
          <p:cNvSpPr txBox="1"/>
          <p:nvPr/>
        </p:nvSpPr>
        <p:spPr>
          <a:xfrm>
            <a:off x="0" y="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3D6331C-010B-4301-B5A4-50F6B8ED5345}"/>
              </a:ext>
            </a:extLst>
          </p:cNvPr>
          <p:cNvSpPr txBox="1"/>
          <p:nvPr/>
        </p:nvSpPr>
        <p:spPr>
          <a:xfrm>
            <a:off x="708660" y="226094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AE4DD2A-D64A-4D19-89B3-77D9C2248B6D}"/>
              </a:ext>
            </a:extLst>
          </p:cNvPr>
          <p:cNvSpPr txBox="1"/>
          <p:nvPr/>
        </p:nvSpPr>
        <p:spPr>
          <a:xfrm>
            <a:off x="3997678" y="226658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8155764-E544-4939-B205-5BD01424B661}"/>
              </a:ext>
            </a:extLst>
          </p:cNvPr>
          <p:cNvSpPr txBox="1"/>
          <p:nvPr/>
        </p:nvSpPr>
        <p:spPr>
          <a:xfrm>
            <a:off x="15240" y="434721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C058EE1-9BBA-4DE6-8723-94ACDB0DCF75}"/>
              </a:ext>
            </a:extLst>
          </p:cNvPr>
          <p:cNvSpPr txBox="1"/>
          <p:nvPr/>
        </p:nvSpPr>
        <p:spPr>
          <a:xfrm>
            <a:off x="708660" y="450122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BC9DF35-8B39-4895-B716-1EDFAA7FAD89}"/>
              </a:ext>
            </a:extLst>
          </p:cNvPr>
          <p:cNvSpPr txBox="1"/>
          <p:nvPr/>
        </p:nvSpPr>
        <p:spPr>
          <a:xfrm>
            <a:off x="3997678" y="450686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EBABE77-10C9-41FE-93EC-DF11EB866820}"/>
              </a:ext>
            </a:extLst>
          </p:cNvPr>
          <p:cNvSpPr txBox="1"/>
          <p:nvPr/>
        </p:nvSpPr>
        <p:spPr>
          <a:xfrm>
            <a:off x="712470" y="661958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DE9FB2B-8A6F-4D7D-BDDE-B109B99A8EB2}"/>
              </a:ext>
            </a:extLst>
          </p:cNvPr>
          <p:cNvSpPr txBox="1"/>
          <p:nvPr/>
        </p:nvSpPr>
        <p:spPr>
          <a:xfrm>
            <a:off x="4001488" y="662522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3679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66</TotalTime>
  <Words>673</Words>
  <Application>Microsoft Office PowerPoint</Application>
  <PresentationFormat>画面に合わせる (4:3)</PresentationFormat>
  <Paragraphs>9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Seino</dc:creator>
  <cp:lastModifiedBy>Seino Satoshi</cp:lastModifiedBy>
  <cp:revision>347</cp:revision>
  <cp:lastPrinted>2019-04-05T09:48:00Z</cp:lastPrinted>
  <dcterms:created xsi:type="dcterms:W3CDTF">2019-01-07T07:45:10Z</dcterms:created>
  <dcterms:modified xsi:type="dcterms:W3CDTF">2022-02-10T10:03:35Z</dcterms:modified>
</cp:coreProperties>
</file>